
<file path=[Content_Types].xml><?xml version="1.0" encoding="utf-8"?>
<Types xmlns="http://schemas.openxmlformats.org/package/2006/content-types"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70" autoAdjust="0"/>
    <p:restoredTop sz="94660"/>
  </p:normalViewPr>
  <p:slideViewPr>
    <p:cSldViewPr snapToGrid="0">
      <p:cViewPr varScale="1">
        <p:scale>
          <a:sx n="70" d="100"/>
          <a:sy n="70" d="100"/>
        </p:scale>
        <p:origin x="660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1F234-7924-4E36-BE71-CA140AC9CDC6}" type="datetimeFigureOut">
              <a:rPr lang="en-US" smtClean="0"/>
              <a:t>2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5482E-156D-436F-8814-30D7A1BA2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36323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1F234-7924-4E36-BE71-CA140AC9CDC6}" type="datetimeFigureOut">
              <a:rPr lang="en-US" smtClean="0"/>
              <a:t>2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5482E-156D-436F-8814-30D7A1BA2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09046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1F234-7924-4E36-BE71-CA140AC9CDC6}" type="datetimeFigureOut">
              <a:rPr lang="en-US" smtClean="0"/>
              <a:t>2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5482E-156D-436F-8814-30D7A1BA2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29587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1F234-7924-4E36-BE71-CA140AC9CDC6}" type="datetimeFigureOut">
              <a:rPr lang="en-US" smtClean="0"/>
              <a:t>2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5482E-156D-436F-8814-30D7A1BA2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45373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1F234-7924-4E36-BE71-CA140AC9CDC6}" type="datetimeFigureOut">
              <a:rPr lang="en-US" smtClean="0"/>
              <a:t>2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5482E-156D-436F-8814-30D7A1BA2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6783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1F234-7924-4E36-BE71-CA140AC9CDC6}" type="datetimeFigureOut">
              <a:rPr lang="en-US" smtClean="0"/>
              <a:t>2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5482E-156D-436F-8814-30D7A1BA2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06648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1F234-7924-4E36-BE71-CA140AC9CDC6}" type="datetimeFigureOut">
              <a:rPr lang="en-US" smtClean="0"/>
              <a:t>2/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5482E-156D-436F-8814-30D7A1BA2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48215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1F234-7924-4E36-BE71-CA140AC9CDC6}" type="datetimeFigureOut">
              <a:rPr lang="en-US" smtClean="0"/>
              <a:t>2/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5482E-156D-436F-8814-30D7A1BA2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1514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1F234-7924-4E36-BE71-CA140AC9CDC6}" type="datetimeFigureOut">
              <a:rPr lang="en-US" smtClean="0"/>
              <a:t>2/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5482E-156D-436F-8814-30D7A1BA2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64388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1F234-7924-4E36-BE71-CA140AC9CDC6}" type="datetimeFigureOut">
              <a:rPr lang="en-US" smtClean="0"/>
              <a:t>2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5482E-156D-436F-8814-30D7A1BA2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48310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1F234-7924-4E36-BE71-CA140AC9CDC6}" type="datetimeFigureOut">
              <a:rPr lang="en-US" smtClean="0"/>
              <a:t>2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5482E-156D-436F-8814-30D7A1BA2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74527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41F234-7924-4E36-BE71-CA140AC9CDC6}" type="datetimeFigureOut">
              <a:rPr lang="en-US" smtClean="0"/>
              <a:t>2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D5482E-156D-436F-8814-30D7A1BA2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63512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w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2"/>
          <p:cNvPicPr/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242117" y="746298"/>
            <a:ext cx="9301191" cy="169210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Rectangle 4"/>
          <p:cNvSpPr/>
          <p:nvPr/>
        </p:nvSpPr>
        <p:spPr>
          <a:xfrm>
            <a:off x="1136071" y="2912285"/>
            <a:ext cx="9504219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kern="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. </a:t>
            </a:r>
            <a:r>
              <a:rPr lang="en-US" b="1" kern="10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3 </a:t>
            </a:r>
            <a:r>
              <a:rPr lang="en-US" kern="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orty-six IRRI newly released varieties were diagnosed by two </a:t>
            </a:r>
            <a:r>
              <a:rPr lang="en-US" i="1" kern="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ita2</a:t>
            </a:r>
            <a:r>
              <a:rPr lang="en-US" kern="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markers.</a:t>
            </a:r>
            <a:r>
              <a:rPr lang="en-US" b="1" kern="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kern="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: 1Kb Plus DNA ladder. C1: IR64. C2:CO39. Z12F/R is an </a:t>
            </a:r>
            <a:r>
              <a:rPr lang="en-US" kern="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InDel</a:t>
            </a:r>
            <a:r>
              <a:rPr lang="en-US" kern="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marker which has 12bp deletion on </a:t>
            </a:r>
            <a:r>
              <a:rPr lang="en-US" i="1" kern="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ita2</a:t>
            </a:r>
            <a:r>
              <a:rPr lang="en-US" kern="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sequence. 18729F3/R4-PvuII is a CAPs marker which has </a:t>
            </a:r>
            <a:r>
              <a:rPr lang="en-US" kern="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vuII</a:t>
            </a:r>
            <a:r>
              <a:rPr lang="en-US" kern="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cleavage site on CO39 sequence while it has no cleavage site on IR64 sequence. The product size amplified by 18729F3/R4 from CO39 is 825bp. After </a:t>
            </a:r>
            <a:r>
              <a:rPr lang="en-US" kern="1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vuII</a:t>
            </a:r>
            <a:r>
              <a:rPr lang="en-US" kern="1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cleavage, the products are 416bp and 409bp in size. There are 6 varieties (8, 25,27,31,35 and 44) which have deletion in 18729F3/R4 amplification region. One variety (28) is a heterozygote </a:t>
            </a:r>
            <a:r>
              <a:rPr lang="en-US" kern="100" dirty="0" smtClean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with both amplicons at a normal and a smaller size. </a:t>
            </a:r>
            <a:endParaRPr lang="en-US" sz="1600" kern="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90370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6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SimSun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FAO of the U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ou, Bo (FAORAP)</dc:creator>
  <cp:lastModifiedBy>Zhou, Bo (FAORAP)</cp:lastModifiedBy>
  <cp:revision>2</cp:revision>
  <dcterms:created xsi:type="dcterms:W3CDTF">2019-12-04T03:35:18Z</dcterms:created>
  <dcterms:modified xsi:type="dcterms:W3CDTF">2020-02-01T14:16:56Z</dcterms:modified>
</cp:coreProperties>
</file>